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93455" r:id="rId4"/>
  </p:sldMasterIdLst>
  <p:notesMasterIdLst>
    <p:notesMasterId r:id="rId17"/>
  </p:notesMasterIdLst>
  <p:sldIdLst>
    <p:sldId id="310" r:id="rId5"/>
    <p:sldId id="341" r:id="rId6"/>
    <p:sldId id="342" r:id="rId7"/>
    <p:sldId id="344" r:id="rId8"/>
    <p:sldId id="346" r:id="rId9"/>
    <p:sldId id="348" r:id="rId10"/>
    <p:sldId id="349" r:id="rId11"/>
    <p:sldId id="353" r:id="rId12"/>
    <p:sldId id="352" r:id="rId13"/>
    <p:sldId id="351" r:id="rId14"/>
    <p:sldId id="343" r:id="rId15"/>
    <p:sldId id="329" r:id="rId16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012" userDrawn="1">
          <p15:clr>
            <a:srgbClr val="A4A3A4"/>
          </p15:clr>
        </p15:guide>
        <p15:guide id="3" orient="horz" pos="1620">
          <p15:clr>
            <a:srgbClr val="A4A3A4"/>
          </p15:clr>
        </p15:guide>
        <p15:guide id="4" orient="horz" pos="120">
          <p15:clr>
            <a:srgbClr val="A4A3A4"/>
          </p15:clr>
        </p15:guide>
        <p15:guide id="5" orient="horz" pos="756" userDrawn="1">
          <p15:clr>
            <a:srgbClr val="A4A3A4"/>
          </p15:clr>
        </p15:guide>
        <p15:guide id="6" pos="432">
          <p15:clr>
            <a:srgbClr val="A4A3A4"/>
          </p15:clr>
        </p15:guide>
        <p15:guide id="7" pos="5478">
          <p15:clr>
            <a:srgbClr val="A4A3A4"/>
          </p15:clr>
        </p15:guide>
        <p15:guide id="8" pos="2879">
          <p15:clr>
            <a:srgbClr val="A4A3A4"/>
          </p15:clr>
        </p15:guide>
        <p15:guide id="9" orient="horz" pos="424">
          <p15:clr>
            <a:srgbClr val="A4A3A4"/>
          </p15:clr>
        </p15:guide>
        <p15:guide id="10" pos="4781">
          <p15:clr>
            <a:srgbClr val="A4A3A4"/>
          </p15:clr>
        </p15:guide>
        <p15:guide id="11" pos="5471">
          <p15:clr>
            <a:srgbClr val="A4A3A4"/>
          </p15:clr>
        </p15:guide>
        <p15:guide id="12" pos="42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2D2D"/>
    <a:srgbClr val="EDEDEB"/>
    <a:srgbClr val="DBD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4BDDAA3-72E0-4E5D-AB1A-363DABB5F11B}" v="304" dt="2021-03-12T16:27:17.43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39" autoAdjust="0"/>
    <p:restoredTop sz="94753"/>
  </p:normalViewPr>
  <p:slideViewPr>
    <p:cSldViewPr snapToGrid="0" snapToObjects="1">
      <p:cViewPr varScale="1">
        <p:scale>
          <a:sx n="140" d="100"/>
          <a:sy n="140" d="100"/>
        </p:scale>
        <p:origin x="200" y="592"/>
      </p:cViewPr>
      <p:guideLst>
        <p:guide orient="horz" pos="3012"/>
        <p:guide orient="horz" pos="1620"/>
        <p:guide orient="horz" pos="120"/>
        <p:guide orient="horz" pos="756"/>
        <p:guide pos="432"/>
        <p:guide pos="5478"/>
        <p:guide pos="2879"/>
        <p:guide orient="horz" pos="424"/>
        <p:guide pos="4781"/>
        <p:guide pos="5471"/>
        <p:guide pos="42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2E0F2-B694-C44C-A396-27B6C59A926F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6F44A-B88D-2946-8FFA-91DB132F0E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49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131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3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746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2758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0032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2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31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91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15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9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520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2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25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43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505" r:id="rId1"/>
    <p:sldLayoutId id="2147493508" r:id="rId2"/>
    <p:sldLayoutId id="2147493511" r:id="rId3"/>
    <p:sldLayoutId id="2147493468" r:id="rId4"/>
    <p:sldLayoutId id="2147493470" r:id="rId5"/>
    <p:sldLayoutId id="2147493489" r:id="rId6"/>
    <p:sldLayoutId id="2147493471" r:id="rId7"/>
    <p:sldLayoutId id="2147493463" r:id="rId8"/>
    <p:sldLayoutId id="2147493513" r:id="rId9"/>
    <p:sldLayoutId id="2147493474" r:id="rId10"/>
    <p:sldLayoutId id="2147493491" r:id="rId11"/>
    <p:sldLayoutId id="2147493512" r:id="rId12"/>
    <p:sldLayoutId id="2147493483" r:id="rId13"/>
  </p:sldLayoutIdLst>
  <p:hf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medscape.com/viewarticle/567678_1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5" Type="http://schemas.openxmlformats.org/officeDocument/2006/relationships/hyperlink" Target="https://www.uptodate.com/contents/etiology-clinical-manifestations-and-diagnosis-of-volume-depletion-in-adults" TargetMode="External"/><Relationship Id="rId4" Type="http://schemas.openxmlformats.org/officeDocument/2006/relationships/hyperlink" Target="https://emedicine.medscape.com/article/906999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N APPROACH TO DEHYDRATION in the observation unit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/>
              <a:t>Division of Observation Medicin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96A897F-0F06-9C43-9C3B-7FF5ED2B5F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52944" y="4567685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30331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02E980-D45C-E641-A960-21D729E165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DICATIONS FOR DISCHARGE HOM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58A069-6307-3241-BDA5-8AD1FD004113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Normotension, baseline H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turn of Hb/Hct to baseline (resolution of relative polycythemia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bility to self-hydrate and lack of severe thirs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solution of decreased skin turgo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solution of AKI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solution of oliguria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AC463A-95A8-0547-8263-FEB3B7C8B94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513846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964FCD-5B01-3A4D-8593-889FF8BF8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ICATIONS &amp; INDICATIONS FOR FULL ADMI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4FE578-F6F4-A84D-A52F-806F0D332154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evere hyponatremia (&lt;120 mEq/L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Worsening renal failur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rreversible shock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536847-3EE1-B145-9233-2EF669EE19A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59859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4D1AD-4ED9-FB45-99AA-C9188468E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E0598A-C2EA-0B43-8557-059CFB7B527E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1. </a:t>
            </a:r>
            <a:r>
              <a:rPr lang="en-US" dirty="0" err="1"/>
              <a:t>Faes</a:t>
            </a:r>
            <a:r>
              <a:rPr lang="en-US" dirty="0"/>
              <a:t> MC. Dehydration in Geriatrics. Medscape.com. Updated 2007. Accessed January 26, 2019. Available at: </a:t>
            </a:r>
            <a:r>
              <a:rPr lang="en-US" dirty="0">
                <a:hlinkClick r:id="rId3"/>
              </a:rPr>
              <a:t>https://www.medscape.com/viewarticle/567678_1</a:t>
            </a:r>
            <a:endParaRPr lang="en-US" dirty="0">
              <a:cs typeface="Arial"/>
            </a:endParaRPr>
          </a:p>
          <a:p>
            <a:r>
              <a:rPr lang="en-US" dirty="0"/>
              <a:t>Huang LH. Dehydration. Medscape.com. Updated December 7, 2018. Accessed January 26, 2019. available at: </a:t>
            </a:r>
            <a:r>
              <a:rPr lang="en-US" dirty="0">
                <a:solidFill>
                  <a:schemeClr val="bg1"/>
                </a:solidFill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emedicine.medscape.com/article/906999</a:t>
            </a:r>
            <a:endParaRPr lang="en-US" dirty="0">
              <a:solidFill>
                <a:schemeClr val="bg1"/>
              </a:solidFill>
              <a:cs typeface="Arial"/>
            </a:endParaRPr>
          </a:p>
          <a:p>
            <a:r>
              <a:rPr lang="en-US" dirty="0"/>
              <a:t>Sterns RH. </a:t>
            </a:r>
            <a:r>
              <a:rPr lang="en-US" dirty="0">
                <a:ea typeface="+mn-lt"/>
                <a:cs typeface="+mn-lt"/>
              </a:rPr>
              <a:t>Etiology, clinical manifestations, and diagnosis of volume depletion in adults</a:t>
            </a:r>
            <a:r>
              <a:rPr lang="en-US" dirty="0"/>
              <a:t>. Uptodate.com. Updated February 3, 2020. Accessed March 12, 2021. Available at: </a:t>
            </a:r>
            <a:r>
              <a:rPr lang="en-US" dirty="0">
                <a:hlinkClick r:id="rId5"/>
              </a:rPr>
              <a:t>https://www.uptodate.com/contents/etiology-clinical-manifestations-and-diagnosis-of-volume-depletion-in-adults</a:t>
            </a:r>
            <a:endParaRPr lang="en-US" dirty="0">
              <a:cs typeface="Arial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3744B6-0636-9046-B78E-2BA84879934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58992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A1B00E-C302-D347-98F2-74F1B17139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AT IS DEHYDRATION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82057D-527E-C34F-95FF-3CADCF8AC356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/>
              <a:t>A </a:t>
            </a:r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negative fluid balance </a:t>
            </a:r>
            <a:r>
              <a:rPr lang="en-US" dirty="0"/>
              <a:t>caused by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ecreased intake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Seen especially in elderly patien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creased output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GI, renal (ie, effects of diuretic use, osmotic diuresis due to hyperglycemia), or insensible losses (ie, sweating, burns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Fluid shifts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Effusions, ascites, burns, sepsi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D8F33B-7A5B-E144-B895-9EA3A6E17088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34598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3945D-5019-D543-8644-698FB4231D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YPES OF DEHYDR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C82984-B55A-DD4B-A7E5-51659ED11670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499188"/>
            <a:ext cx="7246088" cy="3434319"/>
          </a:xfrm>
        </p:spPr>
        <p:txBody>
          <a:bodyPr>
            <a:normAutofit fontScale="85000" lnSpcReduction="10000"/>
          </a:bodyPr>
          <a:lstStyle/>
          <a:p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Isonatremic </a:t>
            </a:r>
            <a:r>
              <a:rPr lang="en-US" b="1" dirty="0"/>
              <a:t>(130-150 mEq/L) / isotonic dehydr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Most common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Occurs when fluid lost has similar Na concentration to that in the blood.</a:t>
            </a:r>
          </a:p>
          <a:p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Hyponatremic </a:t>
            </a:r>
            <a:r>
              <a:rPr lang="en-US" b="1" dirty="0"/>
              <a:t>(&lt; 130 mEq/L) / hypotonic dehydration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Occurs when fluid lost has greater Na concentration than that in the blood (loss of hypertonic fluid)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ntravascular water shifts to the extravascular space, effectively exaggerating intravascular volume loss.</a:t>
            </a:r>
          </a:p>
          <a:p>
            <a:r>
              <a:rPr lang="en-US" b="1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Hypernatremic</a:t>
            </a:r>
            <a:r>
              <a:rPr lang="en-US" b="1" dirty="0"/>
              <a:t> (&gt;150 mEq/L) / hypertonic dehydr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Occurs when fluid lost has less Na concentration than that in the blood (loss of hypotonic fluid)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Extravascular water shifts to the intravascular space, effectively minimizing intravascular volume loss.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81E65BE-F27B-E044-B726-A11671634B97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56889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C74821-8FD3-C841-8983-F1DCE5526F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MON ETIOLOGIES OF DEHYDRATION SEEN IN OB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9DD9EA-33ED-5D43-B266-6B64F93BDD12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Gastroenteritis associated with nausea, vomiting, and diarrhe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Febrile illness causing insensible loss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evere pain causing decreased PO intak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ecreased PO intake due to inability to ambulate in elderly pati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Patients found down for a prolonged period of time, often associated with rhabdomyolysis and/or contributing co-morbidities</a:t>
            </a:r>
            <a:endParaRPr lang="en-US" dirty="0">
              <a:cs typeface="Arial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A65585-7701-934D-9EF2-F4A0F7B6C654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97194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59228-0A99-4044-B984-0505D1BFBA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PRESENT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C47F79-B79E-ED44-A699-F1655F08C452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zziness / lightheadedne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Hypotensive (</a:t>
            </a:r>
            <a:r>
              <a:rPr lang="en-US" i="1" dirty="0"/>
              <a:t>relative to baseline BP</a:t>
            </a:r>
            <a:r>
              <a:rPr lang="en-US" dirty="0"/>
              <a:t>) +/- tachycardia </a:t>
            </a:r>
            <a:endParaRPr lang="en-US" dirty="0">
              <a:cs typeface="Arial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Orthostas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Oliguri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Muscle cramp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cute weight loss (more common in elderly patients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295586D-B596-7441-BA3F-912F764ABC2D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78881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C3652A-E164-8741-A13D-0CB02D93C7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HYSICAL EXAM FINDING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B35008-5B81-D441-929D-3C741BF48229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Lethargy / confus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unken ey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ry mucus membranes / dry axillary reg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ecreased skin turgor (check skin overlying sternum or inner thighs in elderly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ecreased jugular venous pressure (JVP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6349B8-9525-EB4F-BDA9-51E94D0329A3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21807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DB254E-004E-D440-9728-67D644589D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BS/ IMAG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2DBDD0-6B08-5441-A516-D1F5F86CC2D2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799" y="1669312"/>
            <a:ext cx="7299251" cy="3020163"/>
          </a:xfrm>
        </p:spPr>
        <p:txBody>
          <a:bodyPr vert="horz" lIns="0" tIns="0" rIns="0" bIns="0" numCol="2" rtlCol="0" anchor="t">
            <a:normAutofit fontScale="77500" lnSpcReduction="2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Electrolyte imbalance </a:t>
            </a:r>
            <a:endParaRPr lang="en-US" dirty="0">
              <a:solidFill>
                <a:schemeClr val="accent1">
                  <a:lumMod val="20000"/>
                  <a:lumOff val="80000"/>
                </a:schemeClr>
              </a:solidFill>
              <a:cs typeface="Arial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Low urine sodium</a:t>
            </a:r>
            <a:r>
              <a:rPr lang="en-US" dirty="0"/>
              <a:t> &lt;20 mEq/L (unless on diuretics or presence of chronic kidney disease (CKD), congestive heart failure (CHF), cirrhosis, or other conditions with impaired sodium resorption)</a:t>
            </a:r>
            <a:endParaRPr lang="en-US" dirty="0">
              <a:cs typeface="Arial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Elevated BUN/Cr ratio </a:t>
            </a:r>
            <a:r>
              <a:rPr lang="en-US" dirty="0"/>
              <a:t>above patient’s baseline with “normal” urinalysis (no protein, cells, and/or casts as seen in CKD)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Can use FeNa&lt;0.1 as an indication of pre-renal acute kidney injury (AKI)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Relative polycythemia (relative to baseline, keeping in mind that elderly patients are often anemic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Metabolic alkalosis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Ie, due to vomiting, diuretic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Metabolic acidosis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Ie, due to diarrhea </a:t>
            </a:r>
            <a:r>
              <a:rPr lang="en-US" dirty="0">
                <a:sym typeface="Wingdings" pitchFamily="2" charset="2"/>
              </a:rPr>
              <a:t> bicarbonate lo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Lactic acidosi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False elevation of albumin </a:t>
            </a:r>
            <a:r>
              <a:rPr lang="en-US" dirty="0"/>
              <a:t>concentration (relative to baseline, since elderly patients often have underlying hypoalbuminemia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2D Echo showing hyperkinetic wall motion </a:t>
            </a:r>
            <a:r>
              <a:rPr lang="en-US" dirty="0"/>
              <a:t>with increased ejection fraction (EF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89E92E-139D-494A-BFFA-739D1D55D815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15213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CB988-670E-1341-86A1-2991F2C0A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/ 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BD6F42-50B8-F243-A673-1BF82569244B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531088"/>
            <a:ext cx="6904038" cy="3338624"/>
          </a:xfrm>
        </p:spPr>
        <p:txBody>
          <a:bodyPr>
            <a:normAutofit fontScale="85000" lnSpcReduction="2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scontinuation of medications such as diuretics, Na bicarb, selective serotonin reuptake inhibitors (SSRIs), tricyclic antidepressants (TCAs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Fluid repletion with repeat basic metabolic panel (BMP) q4 hrs for goal Na=130-134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Isonatremic / hyponatremic patients</a:t>
            </a:r>
          </a:p>
          <a:p>
            <a:pPr marL="1062990" lvl="2" indent="-285750">
              <a:buFont typeface="Arial" panose="020B0604020202020204" pitchFamily="34" charset="0"/>
              <a:buChar char="•"/>
            </a:pPr>
            <a:r>
              <a:rPr lang="en-US" dirty="0"/>
              <a:t>Normal saline vs Lactated Ringer’s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Hypernatremic patients</a:t>
            </a:r>
          </a:p>
          <a:p>
            <a:pPr marL="1062990" lvl="2" indent="-285750">
              <a:buFont typeface="Arial" panose="020B0604020202020204" pitchFamily="34" charset="0"/>
              <a:buChar char="•"/>
            </a:pPr>
            <a:r>
              <a:rPr lang="en-US" dirty="0"/>
              <a:t>Calculate free H</a:t>
            </a:r>
            <a:r>
              <a:rPr lang="en-US" baseline="-25000" dirty="0"/>
              <a:t>2</a:t>
            </a:r>
            <a:r>
              <a:rPr lang="en-US" dirty="0"/>
              <a:t>O deficit and replete with isotonic fluid before consideration of D5W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Electrolyte repletion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K+ with goal &gt; 4 (10 mEq K to increase K by 0.1 mEq/L unless pt. has CKD (then consider using 50% recommended dose) 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r>
              <a:rPr lang="en-US" dirty="0"/>
              <a:t>Mg with goal &gt;2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465524-FEB2-BB47-A5EA-1D3B33406350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58636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339598-E6AD-B746-8A75-26F4704D8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TERMINING RESPONSE TO 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DFE78D-1CF4-2C47-9319-07B4EF7DCAA5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 lnSpcReduction="1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Vitals q4 hours (including orthostatics if indicated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peat BMP q12 hrs to evaluate for resolution of AKI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peat BMP q4-6 hrs if hyponatremia or hypokalemia is pres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trict I/O’s and daily weigh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Monitoring for improvement in mental status/ alertne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Resolution of oliguri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Light yellow urin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CC9988-591C-ED40-8C37-78640E04A1A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6777948"/>
      </p:ext>
    </p:extLst>
  </p:cSld>
  <p:clrMapOvr>
    <a:masterClrMapping/>
  </p:clrMapOvr>
</p:sld>
</file>

<file path=ppt/theme/theme1.xml><?xml version="1.0" encoding="utf-8"?>
<a:theme xmlns:a="http://schemas.openxmlformats.org/drawingml/2006/main" name="NYULMC_160829_16x9-Dark_+Boilerplates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Langone_082616_16x9-Dark" id="{16CBEE8A-9587-4812-992D-3553C1FB98F7}" vid="{3F59DFCD-48A1-483A-ADCD-1B4B54D7652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B6F2769-7194-4217-93D3-3AF3A4742282}">
  <ds:schemaRefs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microsoft.com/sharepoint/v3/field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YULMC_160829_16x9-Dark</Template>
  <TotalTime>3595</TotalTime>
  <Words>808</Words>
  <Application>Microsoft Macintosh PowerPoint</Application>
  <PresentationFormat>On-screen Show (16:9)</PresentationFormat>
  <Paragraphs>97</Paragraphs>
  <Slides>1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Lucida Grande</vt:lpstr>
      <vt:lpstr>NYULMC_160829_16x9-Dark_+Boilerplates</vt:lpstr>
      <vt:lpstr>AN APPROACH TO DEHYDRATION in the observation unit</vt:lpstr>
      <vt:lpstr>WHAT IS DEHYDRATION?</vt:lpstr>
      <vt:lpstr>TYPES OF DEHYDRATION</vt:lpstr>
      <vt:lpstr>COMMON ETIOLOGIES OF DEHYDRATION SEEN IN OBSERVATION</vt:lpstr>
      <vt:lpstr>CLINICAL PRESENTATION</vt:lpstr>
      <vt:lpstr>PHYSICAL EXAM FINDINGS</vt:lpstr>
      <vt:lpstr>LABS/ IMAGING</vt:lpstr>
      <vt:lpstr>TREATMENT/ THERAPY</vt:lpstr>
      <vt:lpstr>DETERMINING RESPONSE TO THERAPY</vt:lpstr>
      <vt:lpstr>INDICATIONS FOR DISCHARGE HOME</vt:lpstr>
      <vt:lpstr>COMPLICATIONS &amp; INDICATIONS FOR FULL ADMISSION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CATION RECONCILIATION</dc:title>
  <dc:creator>Barie Salmon</dc:creator>
  <cp:lastModifiedBy>Alisa Wray</cp:lastModifiedBy>
  <cp:revision>172</cp:revision>
  <dcterms:created xsi:type="dcterms:W3CDTF">2017-06-02T12:45:43Z</dcterms:created>
  <dcterms:modified xsi:type="dcterms:W3CDTF">2021-04-12T18:30:04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